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1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" orient="horz" pos="3984" userDrawn="1">
          <p15:clr>
            <a:srgbClr val="A4A3A4"/>
          </p15:clr>
        </p15:guide>
        <p15:guide id="10" orient="horz" pos="5688" userDrawn="1">
          <p15:clr>
            <a:srgbClr val="A4A3A4"/>
          </p15:clr>
        </p15:guide>
        <p15:guide id="12" pos="2160" userDrawn="1">
          <p15:clr>
            <a:srgbClr val="A4A3A4"/>
          </p15:clr>
        </p15:guide>
        <p15:guide id="32" pos="244">
          <p15:clr>
            <a:srgbClr val="A4A3A4"/>
          </p15:clr>
        </p15:guide>
        <p15:guide id="41" pos="4080" userDrawn="1">
          <p15:clr>
            <a:srgbClr val="A4A3A4"/>
          </p15:clr>
        </p15:guide>
        <p15:guide id="44" orient="horz" pos="1488" userDrawn="1">
          <p15:clr>
            <a:srgbClr val="A4A3A4"/>
          </p15:clr>
        </p15:guide>
        <p15:guide id="45" pos="1464" userDrawn="1">
          <p15:clr>
            <a:srgbClr val="A4A3A4"/>
          </p15:clr>
        </p15:guide>
        <p15:guide id="46" pos="91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e" initials="J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2C0EE2"/>
    <a:srgbClr val="FF00FF"/>
    <a:srgbClr val="0E7C28"/>
    <a:srgbClr val="FA714C"/>
    <a:srgbClr val="D0E8D4"/>
    <a:srgbClr val="98F6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9592" autoAdjust="0"/>
    <p:restoredTop sz="88016" autoAdjust="0"/>
  </p:normalViewPr>
  <p:slideViewPr>
    <p:cSldViewPr snapToGrid="0" showGuides="1">
      <p:cViewPr varScale="1">
        <p:scale>
          <a:sx n="86" d="100"/>
          <a:sy n="86" d="100"/>
        </p:scale>
        <p:origin x="3936" y="200"/>
      </p:cViewPr>
      <p:guideLst>
        <p:guide orient="horz" pos="3984"/>
        <p:guide orient="horz" pos="5688"/>
        <p:guide pos="2160"/>
        <p:guide pos="244"/>
        <p:guide pos="4080"/>
        <p:guide orient="horz" pos="1488"/>
        <p:guide pos="1464"/>
        <p:guide pos="91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24B9B2-9A98-44F8-B9A3-CCE9D21813A9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2901FE-BE7D-4226-A372-8424301D3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2701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2901FE-BE7D-4226-A372-8424301D3E5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1815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287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689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40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232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052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497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732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960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959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632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471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802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jpe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5474" y="10147"/>
            <a:ext cx="7662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S3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71" t="26934" r="39584" b="5618"/>
          <a:stretch/>
        </p:blipFill>
        <p:spPr bwMode="auto">
          <a:xfrm flipH="1" flipV="1">
            <a:off x="982321" y="1715935"/>
            <a:ext cx="788437" cy="5383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36" t="29014" r="39037" b="3379"/>
          <a:stretch/>
        </p:blipFill>
        <p:spPr bwMode="auto">
          <a:xfrm flipH="1" flipV="1">
            <a:off x="983166" y="2820192"/>
            <a:ext cx="787592" cy="5456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67" t="25173" r="38988" b="7225"/>
          <a:stretch/>
        </p:blipFill>
        <p:spPr bwMode="auto">
          <a:xfrm flipH="1" flipV="1">
            <a:off x="982334" y="2272397"/>
            <a:ext cx="788419" cy="536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5" name="Straight Connector 34"/>
          <p:cNvCxnSpPr/>
          <p:nvPr/>
        </p:nvCxnSpPr>
        <p:spPr>
          <a:xfrm>
            <a:off x="1588941" y="2206120"/>
            <a:ext cx="142055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01" name="Picture 5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56" t="19039" r="40778" b="31443"/>
          <a:stretch/>
        </p:blipFill>
        <p:spPr bwMode="auto">
          <a:xfrm rot="10800000">
            <a:off x="1785266" y="1715074"/>
            <a:ext cx="1028712" cy="5392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25" t="12024" r="40825" b="39168"/>
          <a:stretch/>
        </p:blipFill>
        <p:spPr bwMode="auto">
          <a:xfrm rot="10800000">
            <a:off x="1785263" y="2820194"/>
            <a:ext cx="1028714" cy="5456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56" t="16504" r="40778" b="35130"/>
          <a:stretch/>
        </p:blipFill>
        <p:spPr bwMode="auto">
          <a:xfrm rot="10800000">
            <a:off x="1785266" y="2272394"/>
            <a:ext cx="1028712" cy="5364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6" name="Straight Connector 35"/>
          <p:cNvCxnSpPr/>
          <p:nvPr/>
        </p:nvCxnSpPr>
        <p:spPr>
          <a:xfrm rot="10800000">
            <a:off x="2422156" y="2206115"/>
            <a:ext cx="354978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04" name="Picture 8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76" t="21795" r="27778" b="19594"/>
          <a:stretch/>
        </p:blipFill>
        <p:spPr bwMode="auto">
          <a:xfrm>
            <a:off x="3220926" y="1715936"/>
            <a:ext cx="1273871" cy="5383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523" t="22909" r="27756" b="20966"/>
          <a:stretch/>
        </p:blipFill>
        <p:spPr bwMode="auto">
          <a:xfrm>
            <a:off x="3213407" y="2269619"/>
            <a:ext cx="1281391" cy="5392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76" t="19004" r="27778" b="15213"/>
          <a:stretch/>
        </p:blipFill>
        <p:spPr bwMode="auto">
          <a:xfrm>
            <a:off x="3220932" y="2821215"/>
            <a:ext cx="1273866" cy="544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46" name="Straight Connector 45"/>
          <p:cNvCxnSpPr/>
          <p:nvPr/>
        </p:nvCxnSpPr>
        <p:spPr>
          <a:xfrm flipH="1">
            <a:off x="5750471" y="2203040"/>
            <a:ext cx="4572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flipH="1">
            <a:off x="4234404" y="2206067"/>
            <a:ext cx="222873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405573" y="1862533"/>
            <a:ext cx="812531" cy="218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Merge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412127" y="2399786"/>
            <a:ext cx="1120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RP27p:</a:t>
            </a:r>
          </a:p>
          <a:p>
            <a:r>
              <a:rPr lang="en-US" sz="900" dirty="0" err="1"/>
              <a:t>tdTomato</a:t>
            </a:r>
            <a:endParaRPr lang="en-US" sz="900" dirty="0"/>
          </a:p>
        </p:txBody>
      </p:sp>
      <p:sp>
        <p:nvSpPr>
          <p:cNvPr id="50" name="TextBox 49"/>
          <p:cNvSpPr txBox="1"/>
          <p:nvPr/>
        </p:nvSpPr>
        <p:spPr>
          <a:xfrm>
            <a:off x="412127" y="2919096"/>
            <a:ext cx="1091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PWL2p:</a:t>
            </a:r>
          </a:p>
          <a:p>
            <a:r>
              <a:rPr lang="en-US" sz="900" dirty="0"/>
              <a:t>EGFP</a:t>
            </a:r>
          </a:p>
        </p:txBody>
      </p:sp>
      <p:sp>
        <p:nvSpPr>
          <p:cNvPr id="53" name="TextBox 52"/>
          <p:cNvSpPr txBox="1"/>
          <p:nvPr/>
        </p:nvSpPr>
        <p:spPr>
          <a:xfrm rot="16200000">
            <a:off x="5086920" y="2408717"/>
            <a:ext cx="15992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Highly sensitive setting</a:t>
            </a:r>
          </a:p>
        </p:txBody>
      </p:sp>
      <p:cxnSp>
        <p:nvCxnSpPr>
          <p:cNvPr id="54" name="Straight Connector 53"/>
          <p:cNvCxnSpPr/>
          <p:nvPr/>
        </p:nvCxnSpPr>
        <p:spPr>
          <a:xfrm>
            <a:off x="5778962" y="1707500"/>
            <a:ext cx="0" cy="16459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976152" y="1493795"/>
            <a:ext cx="803378" cy="2180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Live sheath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779532" y="1503364"/>
            <a:ext cx="1040174" cy="2180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Dead sheath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213407" y="1495596"/>
            <a:ext cx="1273872" cy="2180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Live onion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498145" y="1494696"/>
            <a:ext cx="12261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Dead onio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E37153C-DBB4-49DC-A10A-9A777A936F5C}"/>
              </a:ext>
            </a:extLst>
          </p:cNvPr>
          <p:cNvSpPr txBox="1"/>
          <p:nvPr/>
        </p:nvSpPr>
        <p:spPr>
          <a:xfrm>
            <a:off x="311111" y="1247960"/>
            <a:ext cx="418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a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4918F4D-BDED-412A-94FD-EC828A54628A}"/>
              </a:ext>
            </a:extLst>
          </p:cNvPr>
          <p:cNvSpPr txBox="1"/>
          <p:nvPr/>
        </p:nvSpPr>
        <p:spPr>
          <a:xfrm>
            <a:off x="2889598" y="1247960"/>
            <a:ext cx="3615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b)</a:t>
            </a:r>
          </a:p>
        </p:txBody>
      </p:sp>
      <p:pic>
        <p:nvPicPr>
          <p:cNvPr id="37" name="Picture 2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26" t="19052" r="41437" b="19516"/>
          <a:stretch/>
        </p:blipFill>
        <p:spPr bwMode="auto">
          <a:xfrm flipH="1">
            <a:off x="4513624" y="1718317"/>
            <a:ext cx="1210654" cy="5359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8" name="Picture 4"/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47" t="19223" r="40916" b="20419"/>
          <a:stretch/>
        </p:blipFill>
        <p:spPr bwMode="auto">
          <a:xfrm flipH="1">
            <a:off x="4513624" y="2821215"/>
            <a:ext cx="1210654" cy="5446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9" name="Picture 5"/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46" t="19197" r="41051" b="20364"/>
          <a:stretch/>
        </p:blipFill>
        <p:spPr bwMode="auto">
          <a:xfrm flipH="1">
            <a:off x="4513624" y="2269619"/>
            <a:ext cx="1210654" cy="5392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209A56C6-6F1E-4449-8932-B8F628873138}"/>
              </a:ext>
            </a:extLst>
          </p:cNvPr>
          <p:cNvCxnSpPr/>
          <p:nvPr/>
        </p:nvCxnSpPr>
        <p:spPr>
          <a:xfrm flipH="1">
            <a:off x="5458052" y="2199770"/>
            <a:ext cx="222873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85327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228</TotalTime>
  <Words>27</Words>
  <Application>Microsoft Macintosh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Georgia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e Zhu</dc:creator>
  <cp:lastModifiedBy>Anon</cp:lastModifiedBy>
  <cp:revision>1200</cp:revision>
  <cp:lastPrinted>2020-03-02T17:55:46Z</cp:lastPrinted>
  <dcterms:created xsi:type="dcterms:W3CDTF">2019-02-08T19:32:18Z</dcterms:created>
  <dcterms:modified xsi:type="dcterms:W3CDTF">2020-10-22T07:33:10Z</dcterms:modified>
</cp:coreProperties>
</file>